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9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82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09565A-65A4-EB8F-5CC4-22700530BB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FADF36F-81FD-C81C-F7F1-4C6C389A26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AB1B87-5977-8D25-6D85-2A16B6540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74B2C2-F6A9-9926-EFB2-4269F1594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E3A542-7A86-E3E2-AF9D-433750043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272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E75124-92F0-36A9-37AB-FC329CB334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B8D4EE-BFFB-53DB-90E8-13190D8764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051B33-1BA3-567D-1685-2177BF6F8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57E093-8887-B57D-3717-34ACA6548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5CBD60-CDCF-7FA5-73D2-EFE4570BD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0189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5BD01D1-0394-BE25-813C-B0EB631319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D8B140B-4488-F587-9AEF-A54124FAAD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95649D-4A04-5EBC-F02C-DDFF23885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213C91-0E28-7693-A180-2260240BF8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B02A4E-E586-E75E-E454-FD71F479C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7637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81907A-7AC4-2FD6-3687-C14353C5E1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6916400-7169-4F49-3D67-A8ED8D68E0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CED610-5974-8855-A1FE-792A37019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2FFE98-1750-AE4F-3011-8F5231391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3A3732-4708-2870-9BF1-76DD4FEF3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1123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C20607-889A-48DD-54F3-75143B284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142CF6-A500-D981-21E1-BC3FFF7A14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9681F9-60FD-4229-2E04-A65A6B98F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9B09F2-88BF-330C-C61D-7357A46D8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5EB143-4E29-0EE4-1B9E-C3F3BAAF2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182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B53551-81B2-129A-8A58-F0B3F6EFCD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29E125-6A78-6ED9-0C25-56FB9E11B4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17AB34A-0C58-723A-E347-E0B17DC7D6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D4CF29-A480-F091-9739-F25406573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C8D0A2B-EF1C-00EA-DE09-8B8B8980B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FA3555-DFD9-E3B3-93B0-3FEA52C1F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8885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5FFBF3-F2E3-AAEE-5F4C-758A67258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DE532D-6E12-E82F-228F-6B9AA93ED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FC1C3BA-CFE6-67FA-111C-0D4E0A820C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27C3046-15A3-D4C7-1420-FAFE52FEE8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952F5B0-795F-004A-DBE3-163F692A7A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E2B8FC0-2C1D-AFAF-9E33-77D0F6736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6DB0093-8CD0-51BB-5D2F-A7AC243D0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F022436-2228-B970-D4E7-3335E07B9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248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CD720E-9BE3-87AD-ECBE-5EA6E187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3FDA8DA-5EEF-7093-BE30-158233E9B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DAFB411-8184-9701-5A64-15A9FC43B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E34589A-7E7D-6542-3615-260CB2869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9781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1BC7B28-E843-59AF-CF33-8DEDC7FC4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79A5A61-369A-9ED8-E115-DEA25E9BD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3EEDEBE-C55B-724A-03BB-CAF43B0F9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8578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D950AE-0520-73F1-2A80-62402B85E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A82EC8C-0956-6E6D-5532-BBD6AB8B78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6F5C11-8E74-9C86-CCEC-93E9A96FE9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858AE3C-180E-D31D-9126-412278BDCC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89CFB5-570F-09FD-E99E-28174F676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18FEEA3-B59B-110E-FF9A-9A09FFE40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8941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79D1D0-E66B-FE6D-0121-4B108921A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AED5B5B-C4D8-025D-CBA2-6294BBCBF8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C28615D-EC41-E0DA-1CAF-0928042C0E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43BE1FE-A397-37E9-C6F5-512BBD1EF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15BF61D-B5EF-E22A-B99C-C4CD9612D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47E7234-68C0-44F6-B21C-1CEC4232DB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0409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5F2BCAB-5E7F-01F2-D764-A6C7740FD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39ECBE-9C05-EE48-DA9B-862509C9E7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BEB2F1-B59D-3D73-9FBD-465B646D18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81099-D9CF-45F8-B96B-CA664B0E604A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A25863-3285-8B59-0120-0A72D78DFC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818CD9-E8B5-82F2-3C79-EB4B789C52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ADA46-37AB-4480-856B-A51B597E28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0283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3.mp4"/><Relationship Id="rId7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6" Type="http://schemas.openxmlformats.org/officeDocument/2006/relationships/tags" Target="../tags/tag2.xml"/><Relationship Id="rId5" Type="http://schemas.openxmlformats.org/officeDocument/2006/relationships/tags" Target="../tags/tag1.xml"/><Relationship Id="rId4" Type="http://schemas.openxmlformats.org/officeDocument/2006/relationships/video" Target="../media/media3.mp4"/><Relationship Id="rId9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房间隔穿刺至副房">
            <a:hlinkClick r:id="" action="ppaction://media"/>
            <a:extLst>
              <a:ext uri="{FF2B5EF4-FFF2-40B4-BE49-F238E27FC236}">
                <a16:creationId xmlns:a16="http://schemas.microsoft.com/office/drawing/2014/main" id="{8CF64D85-2950-B011-57A4-EF3FC943E7F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803400" y="1021433"/>
            <a:ext cx="8020049" cy="501253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12AFCDA-F8AE-94F0-E9FC-09DA8CBA170B}"/>
              </a:ext>
            </a:extLst>
          </p:cNvPr>
          <p:cNvSpPr txBox="1"/>
          <p:nvPr/>
        </p:nvSpPr>
        <p:spPr>
          <a:xfrm>
            <a:off x="190500" y="256117"/>
            <a:ext cx="10363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2: ICE-guided septal puncture.</a:t>
            </a:r>
          </a:p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1: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 b="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ncture of the atrial septum into the accessory left atrial chamber guided by ICE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59995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2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左肺静脉造影">
            <a:hlinkClick r:id="" action="ppaction://media"/>
            <a:extLst>
              <a:ext uri="{FF2B5EF4-FFF2-40B4-BE49-F238E27FC236}">
                <a16:creationId xmlns:a16="http://schemas.microsoft.com/office/drawing/2014/main" id="{CC2FC88E-56CD-BB54-1058-13CF2E15C33F}"/>
              </a:ext>
            </a:extLst>
          </p:cNvPr>
          <p:cNvPicPr/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454150" y="1952977"/>
            <a:ext cx="4303473" cy="4240985"/>
          </a:xfrm>
          <a:prstGeom prst="rect">
            <a:avLst/>
          </a:prstGeom>
        </p:spPr>
      </p:pic>
      <p:pic>
        <p:nvPicPr>
          <p:cNvPr id="12" name="右肺静脉造影">
            <a:hlinkClick r:id="" action="ppaction://media"/>
            <a:extLst>
              <a:ext uri="{FF2B5EF4-FFF2-40B4-BE49-F238E27FC236}">
                <a16:creationId xmlns:a16="http://schemas.microsoft.com/office/drawing/2014/main" id="{B14A4729-BCCA-D7B3-465C-2457F5D72BB4}"/>
              </a:ext>
            </a:extLst>
          </p:cNvPr>
          <p:cNvPicPr/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6329965" y="1920297"/>
            <a:ext cx="4530652" cy="4306231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04AF43F-757B-5C75-9154-5CDD2F08D219}"/>
              </a:ext>
            </a:extLst>
          </p:cNvPr>
          <p:cNvSpPr txBox="1"/>
          <p:nvPr/>
        </p:nvSpPr>
        <p:spPr>
          <a:xfrm>
            <a:off x="156322" y="206512"/>
            <a:ext cx="968617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2: The pulmonary venography.</a:t>
            </a:r>
          </a:p>
          <a:p>
            <a:pPr algn="just"/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dieo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A-B: The pulmonary venography confirmed catheter sheath </a:t>
            </a:r>
            <a:r>
              <a:rPr kumimoji="0" lang="en-US" altLang="zh-CN" sz="1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tered the accessory chamber (A-B).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sz="16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: the </a:t>
            </a:r>
            <a:r>
              <a:rPr lang="en-US" altLang="zh-CN" sz="160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ulmonary venography (LAO </a:t>
            </a:r>
            <a:r>
              <a:rPr lang="en-US" altLang="zh-CN" sz="16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5°</a:t>
            </a:r>
            <a:r>
              <a:rPr lang="en-US" altLang="zh-CN" sz="160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clearly displayed the LSPV and LIPV after </a:t>
            </a:r>
            <a:r>
              <a:rPr lang="en-US" altLang="zh-CN" sz="1600" b="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mpleting </a:t>
            </a:r>
            <a:r>
              <a:rPr lang="en-US" altLang="zh-CN" sz="160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atrial septal puncture</a:t>
            </a:r>
            <a:r>
              <a:rPr lang="en-US" altLang="zh-CN" sz="16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zh-CN" altLang="en-US" sz="16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:</a:t>
            </a:r>
            <a:r>
              <a:rPr lang="en-US" altLang="zh-CN" sz="160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pulmonary venography (RAO 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r>
              <a:rPr lang="en-US" altLang="zh-CN" sz="16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r>
              <a:rPr lang="en-US" altLang="zh-CN" sz="160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clearly displayed the RSPV, RIPV and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embrane </a:t>
            </a:r>
            <a:r>
              <a:rPr lang="en-US" altLang="zh-CN" sz="160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annel after </a:t>
            </a:r>
            <a:r>
              <a:rPr lang="en-US" altLang="zh-CN" sz="1600" b="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mpleting </a:t>
            </a:r>
            <a:r>
              <a:rPr lang="en-US" altLang="zh-CN" sz="160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atrial septal puncture.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0E677B5-F104-EBA2-C110-561CB6C1C854}"/>
              </a:ext>
            </a:extLst>
          </p:cNvPr>
          <p:cNvSpPr txBox="1"/>
          <p:nvPr/>
        </p:nvSpPr>
        <p:spPr>
          <a:xfrm>
            <a:off x="1454150" y="1939634"/>
            <a:ext cx="3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A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5" name="文本框 5">
            <a:extLst>
              <a:ext uri="{FF2B5EF4-FFF2-40B4-BE49-F238E27FC236}">
                <a16:creationId xmlns:a16="http://schemas.microsoft.com/office/drawing/2014/main" id="{48FBF463-E2CF-4C16-267C-C98B50375209}"/>
              </a:ext>
            </a:extLst>
          </p:cNvPr>
          <p:cNvSpPr txBox="1"/>
          <p:nvPr/>
        </p:nvSpPr>
        <p:spPr>
          <a:xfrm>
            <a:off x="6329965" y="1939634"/>
            <a:ext cx="3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solidFill>
                  <a:srgbClr val="FF0000"/>
                </a:solidFill>
              </a:rPr>
              <a:t>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AE45253-AE81-CCD8-915D-5085EE31EE03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1454150" y="5784817"/>
            <a:ext cx="43034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O </a:t>
            </a:r>
            <a:r>
              <a:rPr lang="en-US" altLang="zh-CN" sz="200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5°</a:t>
            </a:r>
            <a:r>
              <a:rPr lang="en-US" altLang="zh-CN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2E422FC-9509-3CC3-AB6C-60FB5DCE748C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6329965" y="5810474"/>
            <a:ext cx="4530652" cy="400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  <a:sym typeface="+mn-ea"/>
              </a:rPr>
              <a:t>RAO 30</a:t>
            </a:r>
            <a:r>
              <a:rPr lang="en-US" altLang="zh-CN" sz="200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°</a:t>
            </a:r>
            <a:r>
              <a:rPr lang="en-US" altLang="zh-CN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altLang="zh-CN" sz="2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+mn-ea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35A586C1-36A8-5E94-55BE-8B6B34DE0EB1}"/>
              </a:ext>
            </a:extLst>
          </p:cNvPr>
          <p:cNvSpPr/>
          <p:nvPr/>
        </p:nvSpPr>
        <p:spPr>
          <a:xfrm>
            <a:off x="4940300" y="1958684"/>
            <a:ext cx="817322" cy="130664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0CAD4628-D0EA-C0DC-84A6-5311453263A9}"/>
              </a:ext>
            </a:extLst>
          </p:cNvPr>
          <p:cNvSpPr/>
          <p:nvPr/>
        </p:nvSpPr>
        <p:spPr>
          <a:xfrm>
            <a:off x="10043295" y="1920297"/>
            <a:ext cx="817322" cy="130664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82250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 additive="base">
                                        <p:cTn id="6" dur="3234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 additive="base">
                                        <p:cTn id="8" dur="2767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9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" fill="hold">
                      <p:stCondLst>
                        <p:cond delay="0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 additive="base">
                                        <p:cTn id="13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 additive="base">
                                        <p:cTn id="18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>
                <p:cTn id="19" repeatCount="indefinite" fill="hold" display="1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video>
              <p:cMediaNode>
                <p:cTn id="20" repeatCount="indefinite" fill="hold" display="1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</p:childTnLst>
        </p:cTn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</TotalTime>
  <Words>103</Words>
  <Application>Microsoft Office PowerPoint</Application>
  <PresentationFormat>宽屏</PresentationFormat>
  <Paragraphs>9</Paragraphs>
  <Slides>2</Slides>
  <Notes>0</Notes>
  <HiddenSlides>0</HiddenSlides>
  <MMClips>3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avin Z</dc:creator>
  <cp:lastModifiedBy>D D</cp:lastModifiedBy>
  <cp:revision>18</cp:revision>
  <dcterms:created xsi:type="dcterms:W3CDTF">2024-05-01T14:40:51Z</dcterms:created>
  <dcterms:modified xsi:type="dcterms:W3CDTF">2024-05-10T12:04:02Z</dcterms:modified>
</cp:coreProperties>
</file>